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90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01" d="100"/>
          <a:sy n="101" d="100"/>
        </p:scale>
        <p:origin x="8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美香 三木" userId="0e1e0125d0a1c367" providerId="LiveId" clId="{331E0618-EFE4-4986-90E8-55A171D2ED15}"/>
    <pc:docChg chg="undo redo custSel modSld">
      <pc:chgData name="美香 三木" userId="0e1e0125d0a1c367" providerId="LiveId" clId="{331E0618-EFE4-4986-90E8-55A171D2ED15}" dt="2024-08-14T06:11:01.541" v="49" actId="1076"/>
      <pc:docMkLst>
        <pc:docMk/>
      </pc:docMkLst>
      <pc:sldChg chg="modSp mod">
        <pc:chgData name="美香 三木" userId="0e1e0125d0a1c367" providerId="LiveId" clId="{331E0618-EFE4-4986-90E8-55A171D2ED15}" dt="2024-08-14T06:11:01.541" v="49" actId="1076"/>
        <pc:sldMkLst>
          <pc:docMk/>
          <pc:sldMk cId="1245705411" sldId="906"/>
        </pc:sldMkLst>
        <pc:spChg chg="mod">
          <ac:chgData name="美香 三木" userId="0e1e0125d0a1c367" providerId="LiveId" clId="{331E0618-EFE4-4986-90E8-55A171D2ED15}" dt="2024-08-14T06:11:01.541" v="49" actId="1076"/>
          <ac:spMkLst>
            <pc:docMk/>
            <pc:sldMk cId="1245705411" sldId="906"/>
            <ac:spMk id="8" creationId="{24FDEADF-7287-144E-D0AB-C038A9A4577B}"/>
          </ac:spMkLst>
        </pc:spChg>
        <pc:spChg chg="mod">
          <ac:chgData name="美香 三木" userId="0e1e0125d0a1c367" providerId="LiveId" clId="{331E0618-EFE4-4986-90E8-55A171D2ED15}" dt="2024-08-14T06:10:05.047" v="47" actId="1076"/>
          <ac:spMkLst>
            <pc:docMk/>
            <pc:sldMk cId="1245705411" sldId="906"/>
            <ac:spMk id="41" creationId="{FF8838AA-5F42-142A-278D-16DBD368BA14}"/>
          </ac:spMkLst>
        </pc:spChg>
        <pc:spChg chg="mod">
          <ac:chgData name="美香 三木" userId="0e1e0125d0a1c367" providerId="LiveId" clId="{331E0618-EFE4-4986-90E8-55A171D2ED15}" dt="2024-08-14T06:10:38.023" v="48" actId="1076"/>
          <ac:spMkLst>
            <pc:docMk/>
            <pc:sldMk cId="1245705411" sldId="906"/>
            <ac:spMk id="42" creationId="{DFB24A47-EAFA-26FB-4887-AB8D0CB270A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3D9947-1659-BF3D-794D-E2127379E9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31AAA27-7A34-3207-7AE1-70BFB40E6E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8511CAB-636D-AF63-BBB4-8E9F26914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5EB71F-C969-A8AE-4AC6-5CB9D6A33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E21872-FA3E-E084-5257-2A82BF58E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1786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C7C02B-814A-CC55-69DF-6E24ED9916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A801DB4-37F7-4CB9-5CE8-1C5199C666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2C542A-173F-048E-730B-296859824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CD094F-6B1C-4B75-22D3-F6EC25CF0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4F63B4E-AF8D-9520-898D-F8C423EA3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386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58A1529-8B5E-D0BA-852B-9F88EF242F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6323196-74A1-718F-ADD2-58F3AF0A5B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03FCE8F-5CAB-08AB-FF93-4250C7D02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70DE2C-1FA9-34A4-99A1-39CC32E82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57A1C3-116C-619D-059D-A36550301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87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9909CC-46F7-401F-94BE-BC2641B1AA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CE18A0-C260-FD35-1B76-BF51B9D14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233584-5626-A84A-BAE2-4CFF745C6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0256C7-8F4E-71A6-8C92-8679EF448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EF2170-DDA9-2570-0FE3-176119262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1110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9B4863-B578-550D-B547-492908E08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ADA3FFF-8660-E5F7-399A-A5A4BB3CF3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D7EFCB-7DE6-EEB0-C83B-35A69DB0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456DEF-DBF6-A97A-BD62-C42E53FAE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F1B47A-9593-D88B-C49B-E6F87A6D5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968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BF4F4D-DF14-C125-344D-80ACDEC2D5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AFB5CF5-A512-DD06-5D0C-2C4B827213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55EF0BD-4B77-1CDD-DE31-50FF45C2A9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173A8B9-55E2-676F-228B-996CB7D98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FBD0C38-4D7C-EDD9-2357-72AD8FA4F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7537FA-B43A-77EC-D250-FDD73A505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498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DD7AE9-182E-3072-E05A-803A8A20F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BFCA1F8-01EA-3E80-AD25-9B79351CFA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B7058B1-D24A-3382-D408-4A10CFCAEC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AB7C911-8B3D-68C0-766A-C9A17D9309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3262E7E-D094-0495-2A28-E71CDA45BB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E243F7E-2E71-74A3-3459-31B7C468F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709A889-4F71-5FEC-21F0-C4532EC09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8FC843A-BA74-DCAD-EB23-90D1FC871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7273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3E0C16-C633-8EDC-D752-9055AA6D07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A83F905-18B5-691B-3FF4-ECCFA091D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72D9D0C-BFBE-45CD-04F1-E9A8107F9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9B3E566-B649-3DE5-97F6-CCEE784ADA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4001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70E4FB6-8B87-FFE6-5AE8-DD11AB904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4FE95FC-28A5-112C-ED2A-E8C03F89E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235F879-4D3B-72C5-BE24-6ED4E9FB8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008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D3731D-6370-B950-550E-3EC63D0F5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C69574-D40A-A57C-2772-8ACA5CF17A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C09E73-C0D5-52C6-B486-EFAA6D89EC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09350E3-4430-68CA-462F-D901EA9C5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94012C1-7006-1D43-173B-DB26E1479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7FBB623-4F69-D884-8D87-0E993442F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2650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F24DE7-DF5E-2F85-B75B-4C71D8B7B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F643750-D9C5-F7EE-A221-1A9534A93F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E76963F-97C0-D23A-60A3-5C4D4C97CC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E81BDBD-D53D-7CD6-2A3C-9889963A7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7E76FD9-E4CA-B235-3577-C51B49DB5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42B414-A6AB-F82A-BA68-A45D054EF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7157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0D93C55-CAE6-F626-7931-DCBD7209F0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7F2373A-BE68-08EB-64E4-ADADE1A7E0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805E1B-36AB-2262-9FF1-DB90019310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34BA74-6155-7A4C-8D41-568EF9D55A88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BAAF2D-B255-554F-D3E8-FA5B3FC27D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8EFF3F-010D-DB9E-F1C2-FE736AEFFF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A8109-0811-2842-8A1D-2E243890E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153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挿絵 が含まれている画像&#10;&#10;自動的に生成された説明">
            <a:extLst>
              <a:ext uri="{FF2B5EF4-FFF2-40B4-BE49-F238E27FC236}">
                <a16:creationId xmlns:a16="http://schemas.microsoft.com/office/drawing/2014/main" id="{C85DB918-82E0-8398-BD56-4DC97B873C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55743" y="2401884"/>
            <a:ext cx="3552700" cy="1430200"/>
          </a:xfrm>
          <a:prstGeom prst="rect">
            <a:avLst/>
          </a:prstGeom>
        </p:spPr>
      </p:pic>
      <p:pic>
        <p:nvPicPr>
          <p:cNvPr id="3" name="図 2" descr="抽象, 挿絵 が含まれている画像&#10;&#10;自動的に生成された説明">
            <a:extLst>
              <a:ext uri="{FF2B5EF4-FFF2-40B4-BE49-F238E27FC236}">
                <a16:creationId xmlns:a16="http://schemas.microsoft.com/office/drawing/2014/main" id="{A008C5E9-A96C-17D1-E767-C1250AB70E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013" y="2401884"/>
            <a:ext cx="3511244" cy="1430200"/>
          </a:xfrm>
          <a:prstGeom prst="rect">
            <a:avLst/>
          </a:prstGeom>
        </p:spPr>
      </p:pic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3B5C963E-7A94-72C9-4299-2DAE934833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19650" y="2401884"/>
            <a:ext cx="3552700" cy="140947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4FDEADF-7287-144E-D0AB-C038A9A4577B}"/>
              </a:ext>
            </a:extLst>
          </p:cNvPr>
          <p:cNvSpPr txBox="1"/>
          <p:nvPr/>
        </p:nvSpPr>
        <p:spPr>
          <a:xfrm>
            <a:off x="9131386" y="1501520"/>
            <a:ext cx="18101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No atrophy</a:t>
            </a:r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56B22672-C5F2-C06E-980D-FC5465D36F35}"/>
              </a:ext>
            </a:extLst>
          </p:cNvPr>
          <p:cNvCxnSpPr/>
          <p:nvPr/>
        </p:nvCxnSpPr>
        <p:spPr>
          <a:xfrm flipV="1">
            <a:off x="2097741" y="3197423"/>
            <a:ext cx="792000" cy="7200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CBA0B0C-550C-E722-B35E-247014A37880}"/>
              </a:ext>
            </a:extLst>
          </p:cNvPr>
          <p:cNvSpPr txBox="1"/>
          <p:nvPr/>
        </p:nvSpPr>
        <p:spPr>
          <a:xfrm>
            <a:off x="1050562" y="4243768"/>
            <a:ext cx="616342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8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ancer extension </a:t>
            </a:r>
          </a:p>
          <a:p>
            <a:pPr algn="ctr"/>
            <a:r>
              <a:rPr lang="en-US" altLang="ja-JP" sz="28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long the main pancreatic duct </a:t>
            </a:r>
            <a:r>
              <a:rPr kumimoji="1" lang="en-US" altLang="ja-JP" sz="28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+)</a:t>
            </a:r>
            <a:endParaRPr kumimoji="1" lang="ja-JP" altLang="en-US" sz="2800" b="1" dirty="0">
              <a:solidFill>
                <a:srgbClr val="FF0000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CA80EBD9-FAFD-F8D7-7BDB-EE6F1FCD7DB5}"/>
              </a:ext>
            </a:extLst>
          </p:cNvPr>
          <p:cNvCxnSpPr/>
          <p:nvPr/>
        </p:nvCxnSpPr>
        <p:spPr>
          <a:xfrm flipV="1">
            <a:off x="6149239" y="3070620"/>
            <a:ext cx="792000" cy="7200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48A4A53-BDD1-52CB-49AD-DBFCED2BFD4B}"/>
              </a:ext>
            </a:extLst>
          </p:cNvPr>
          <p:cNvSpPr txBox="1"/>
          <p:nvPr/>
        </p:nvSpPr>
        <p:spPr>
          <a:xfrm>
            <a:off x="8743937" y="4243768"/>
            <a:ext cx="330462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8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ancer extension</a:t>
            </a:r>
          </a:p>
          <a:p>
            <a:pPr algn="ctr"/>
            <a:r>
              <a:rPr kumimoji="1" lang="en-US" altLang="ja-JP" sz="28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-)</a:t>
            </a:r>
            <a:endParaRPr kumimoji="1" lang="ja-JP" altLang="en-US" sz="3200" b="1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891DD5E1-1564-F1C8-D01F-9D362A86E498}"/>
              </a:ext>
            </a:extLst>
          </p:cNvPr>
          <p:cNvSpPr/>
          <p:nvPr/>
        </p:nvSpPr>
        <p:spPr>
          <a:xfrm flipV="1">
            <a:off x="0" y="1090483"/>
            <a:ext cx="12192000" cy="45719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D08DBA7-463A-3C1D-E139-EC707AEFF6AF}"/>
              </a:ext>
            </a:extLst>
          </p:cNvPr>
          <p:cNvSpPr txBox="1"/>
          <p:nvPr/>
        </p:nvSpPr>
        <p:spPr>
          <a:xfrm>
            <a:off x="427908" y="5648078"/>
            <a:ext cx="79876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section margin positive during surgery: </a:t>
            </a:r>
            <a:r>
              <a:rPr kumimoji="1" lang="en-US" altLang="ja-JP" sz="28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 cases</a:t>
            </a:r>
            <a:endParaRPr kumimoji="1" lang="ja-JP" altLang="en-US" sz="2400" b="1" dirty="0">
              <a:solidFill>
                <a:srgbClr val="FF0000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5FF2889-7389-7BC7-AA57-D802EB62A286}"/>
              </a:ext>
            </a:extLst>
          </p:cNvPr>
          <p:cNvSpPr txBox="1"/>
          <p:nvPr/>
        </p:nvSpPr>
        <p:spPr>
          <a:xfrm>
            <a:off x="-548858" y="6017743"/>
            <a:ext cx="89643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currence at </a:t>
            </a:r>
            <a:r>
              <a:rPr lang="en-US" altLang="ja-JP" sz="2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mnant pancreas after surgery: </a:t>
            </a:r>
            <a:r>
              <a:rPr lang="en-US" altLang="ja-JP" sz="28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 cases</a:t>
            </a:r>
            <a:endParaRPr kumimoji="1" lang="ja-JP" altLang="en-US" sz="2400" b="1" dirty="0">
              <a:solidFill>
                <a:srgbClr val="FF0000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8" name="左中かっこ 37">
            <a:extLst>
              <a:ext uri="{FF2B5EF4-FFF2-40B4-BE49-F238E27FC236}">
                <a16:creationId xmlns:a16="http://schemas.microsoft.com/office/drawing/2014/main" id="{CD1541D1-2F4B-DB9A-2741-2BDEEC417869}"/>
              </a:ext>
            </a:extLst>
          </p:cNvPr>
          <p:cNvSpPr/>
          <p:nvPr/>
        </p:nvSpPr>
        <p:spPr>
          <a:xfrm rot="16200000">
            <a:off x="3944356" y="823587"/>
            <a:ext cx="364605" cy="6480000"/>
          </a:xfrm>
          <a:prstGeom prst="leftBrac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左右矢印 38">
            <a:extLst>
              <a:ext uri="{FF2B5EF4-FFF2-40B4-BE49-F238E27FC236}">
                <a16:creationId xmlns:a16="http://schemas.microsoft.com/office/drawing/2014/main" id="{54755E9B-4BC1-91B0-3ACA-83887606174B}"/>
              </a:ext>
            </a:extLst>
          </p:cNvPr>
          <p:cNvSpPr/>
          <p:nvPr/>
        </p:nvSpPr>
        <p:spPr>
          <a:xfrm>
            <a:off x="8589359" y="5912593"/>
            <a:ext cx="1008000" cy="360000"/>
          </a:xfrm>
          <a:prstGeom prst="left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638E121-BC46-A4B7-71A7-8ACAEDDE6193}"/>
              </a:ext>
            </a:extLst>
          </p:cNvPr>
          <p:cNvSpPr txBox="1"/>
          <p:nvPr/>
        </p:nvSpPr>
        <p:spPr>
          <a:xfrm>
            <a:off x="9771184" y="5830983"/>
            <a:ext cx="17172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 case</a:t>
            </a:r>
            <a:endParaRPr kumimoji="1" lang="ja-JP" altLang="en-US" sz="2800" b="1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F8838AA-5F42-142A-278D-16DBD368BA14}"/>
              </a:ext>
            </a:extLst>
          </p:cNvPr>
          <p:cNvSpPr txBox="1"/>
          <p:nvPr/>
        </p:nvSpPr>
        <p:spPr>
          <a:xfrm>
            <a:off x="177510" y="1319914"/>
            <a:ext cx="42442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Focal pancreatic parenchymal atrophy: FPPA</a:t>
            </a:r>
            <a:endParaRPr kumimoji="1" lang="ja-JP" altLang="en-US" sz="2400" b="1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FB24A47-EAFA-26FB-4887-AB8D0CB270AA}"/>
              </a:ext>
            </a:extLst>
          </p:cNvPr>
          <p:cNvSpPr txBox="1"/>
          <p:nvPr/>
        </p:nvSpPr>
        <p:spPr>
          <a:xfrm>
            <a:off x="4763613" y="1319914"/>
            <a:ext cx="32172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Upstream pancreatic</a:t>
            </a:r>
          </a:p>
          <a:p>
            <a:r>
              <a:rPr lang="en-US" altLang="ja-JP" sz="2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trophy: UPA</a:t>
            </a:r>
            <a:endParaRPr kumimoji="1" lang="ja-JP" altLang="en-US" sz="2400" b="1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3781FC2-E039-6D61-057F-313A9BD324E4}"/>
              </a:ext>
            </a:extLst>
          </p:cNvPr>
          <p:cNvSpPr txBox="1"/>
          <p:nvPr/>
        </p:nvSpPr>
        <p:spPr>
          <a:xfrm>
            <a:off x="380304" y="63528"/>
            <a:ext cx="1154614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2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unga" panose="020B0502040204020203" pitchFamily="34" charset="0"/>
              </a:rPr>
              <a:t>Association of Pancreatic Atrophy Patterns with </a:t>
            </a:r>
          </a:p>
          <a:p>
            <a:pPr algn="just"/>
            <a:r>
              <a:rPr lang="en-US" altLang="ja-JP" sz="2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unga" panose="020B0502040204020203" pitchFamily="34" charset="0"/>
              </a:rPr>
              <a:t>Intraductal Extension of Early Pancreatic Ductal Adenocarcinoma</a:t>
            </a:r>
            <a:endParaRPr lang="ja-JP" altLang="ja-JP" sz="2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unga" panose="020B0502040204020203" pitchFamily="34" charset="0"/>
            </a:endParaRPr>
          </a:p>
        </p:txBody>
      </p:sp>
      <p:sp>
        <p:nvSpPr>
          <p:cNvPr id="2" name="フリーフォーム 1">
            <a:extLst>
              <a:ext uri="{FF2B5EF4-FFF2-40B4-BE49-F238E27FC236}">
                <a16:creationId xmlns:a16="http://schemas.microsoft.com/office/drawing/2014/main" id="{21D32826-111C-8772-2DEC-0DDBC3B44D34}"/>
              </a:ext>
            </a:extLst>
          </p:cNvPr>
          <p:cNvSpPr/>
          <p:nvPr/>
        </p:nvSpPr>
        <p:spPr>
          <a:xfrm>
            <a:off x="2033195" y="2269478"/>
            <a:ext cx="882127" cy="194023"/>
          </a:xfrm>
          <a:custGeom>
            <a:avLst/>
            <a:gdLst>
              <a:gd name="connsiteX0" fmla="*/ 0 w 882127"/>
              <a:gd name="connsiteY0" fmla="*/ 43416 h 194023"/>
              <a:gd name="connsiteX1" fmla="*/ 32273 w 882127"/>
              <a:gd name="connsiteY1" fmla="*/ 54174 h 194023"/>
              <a:gd name="connsiteX2" fmla="*/ 161365 w 882127"/>
              <a:gd name="connsiteY2" fmla="*/ 75689 h 194023"/>
              <a:gd name="connsiteX3" fmla="*/ 225911 w 882127"/>
              <a:gd name="connsiteY3" fmla="*/ 97204 h 194023"/>
              <a:gd name="connsiteX4" fmla="*/ 279699 w 882127"/>
              <a:gd name="connsiteY4" fmla="*/ 129477 h 194023"/>
              <a:gd name="connsiteX5" fmla="*/ 311972 w 882127"/>
              <a:gd name="connsiteY5" fmla="*/ 150993 h 194023"/>
              <a:gd name="connsiteX6" fmla="*/ 408791 w 882127"/>
              <a:gd name="connsiteY6" fmla="*/ 194023 h 194023"/>
              <a:gd name="connsiteX7" fmla="*/ 602429 w 882127"/>
              <a:gd name="connsiteY7" fmla="*/ 161750 h 194023"/>
              <a:gd name="connsiteX8" fmla="*/ 634701 w 882127"/>
              <a:gd name="connsiteY8" fmla="*/ 140235 h 194023"/>
              <a:gd name="connsiteX9" fmla="*/ 742278 w 882127"/>
              <a:gd name="connsiteY9" fmla="*/ 54174 h 194023"/>
              <a:gd name="connsiteX10" fmla="*/ 806824 w 882127"/>
              <a:gd name="connsiteY10" fmla="*/ 32658 h 194023"/>
              <a:gd name="connsiteX11" fmla="*/ 871370 w 882127"/>
              <a:gd name="connsiteY11" fmla="*/ 386 h 194023"/>
              <a:gd name="connsiteX12" fmla="*/ 882127 w 882127"/>
              <a:gd name="connsiteY12" fmla="*/ 386 h 1940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882127" h="194023">
                <a:moveTo>
                  <a:pt x="0" y="43416"/>
                </a:moveTo>
                <a:cubicBezTo>
                  <a:pt x="10758" y="47002"/>
                  <a:pt x="21116" y="52146"/>
                  <a:pt x="32273" y="54174"/>
                </a:cubicBezTo>
                <a:cubicBezTo>
                  <a:pt x="122646" y="70605"/>
                  <a:pt x="95585" y="55955"/>
                  <a:pt x="161365" y="75689"/>
                </a:cubicBezTo>
                <a:cubicBezTo>
                  <a:pt x="183088" y="82206"/>
                  <a:pt x="225911" y="97204"/>
                  <a:pt x="225911" y="97204"/>
                </a:cubicBezTo>
                <a:cubicBezTo>
                  <a:pt x="267935" y="139230"/>
                  <a:pt x="223838" y="101547"/>
                  <a:pt x="279699" y="129477"/>
                </a:cubicBezTo>
                <a:cubicBezTo>
                  <a:pt x="291263" y="135259"/>
                  <a:pt x="300157" y="145742"/>
                  <a:pt x="311972" y="150993"/>
                </a:cubicBezTo>
                <a:cubicBezTo>
                  <a:pt x="427195" y="202204"/>
                  <a:pt x="335750" y="145330"/>
                  <a:pt x="408791" y="194023"/>
                </a:cubicBezTo>
                <a:cubicBezTo>
                  <a:pt x="445696" y="190948"/>
                  <a:pt x="557209" y="191897"/>
                  <a:pt x="602429" y="161750"/>
                </a:cubicBezTo>
                <a:cubicBezTo>
                  <a:pt x="613186" y="154578"/>
                  <a:pt x="624885" y="148649"/>
                  <a:pt x="634701" y="140235"/>
                </a:cubicBezTo>
                <a:cubicBezTo>
                  <a:pt x="672092" y="108185"/>
                  <a:pt x="691351" y="71150"/>
                  <a:pt x="742278" y="54174"/>
                </a:cubicBezTo>
                <a:cubicBezTo>
                  <a:pt x="763793" y="47002"/>
                  <a:pt x="787954" y="45238"/>
                  <a:pt x="806824" y="32658"/>
                </a:cubicBezTo>
                <a:cubicBezTo>
                  <a:pt x="838377" y="11623"/>
                  <a:pt x="835738" y="9294"/>
                  <a:pt x="871370" y="386"/>
                </a:cubicBezTo>
                <a:cubicBezTo>
                  <a:pt x="874849" y="-484"/>
                  <a:pt x="878541" y="386"/>
                  <a:pt x="882127" y="386"/>
                </a:cubicBezTo>
              </a:path>
            </a:pathLst>
          </a:custGeom>
          <a:noFill/>
          <a:ln w="57150">
            <a:solidFill>
              <a:srgbClr val="00B0F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フリーフォーム 10">
            <a:extLst>
              <a:ext uri="{FF2B5EF4-FFF2-40B4-BE49-F238E27FC236}">
                <a16:creationId xmlns:a16="http://schemas.microsoft.com/office/drawing/2014/main" id="{047FB314-CA77-7CBB-465A-9D39152CB23D}"/>
              </a:ext>
            </a:extLst>
          </p:cNvPr>
          <p:cNvSpPr/>
          <p:nvPr/>
        </p:nvSpPr>
        <p:spPr>
          <a:xfrm>
            <a:off x="6078071" y="2334409"/>
            <a:ext cx="1731981" cy="172123"/>
          </a:xfrm>
          <a:custGeom>
            <a:avLst/>
            <a:gdLst>
              <a:gd name="connsiteX0" fmla="*/ 0 w 1731981"/>
              <a:gd name="connsiteY0" fmla="*/ 0 h 172123"/>
              <a:gd name="connsiteX1" fmla="*/ 75303 w 1731981"/>
              <a:gd name="connsiteY1" fmla="*/ 43031 h 172123"/>
              <a:gd name="connsiteX2" fmla="*/ 139849 w 1731981"/>
              <a:gd name="connsiteY2" fmla="*/ 64546 h 172123"/>
              <a:gd name="connsiteX3" fmla="*/ 161364 w 1731981"/>
              <a:gd name="connsiteY3" fmla="*/ 86062 h 172123"/>
              <a:gd name="connsiteX4" fmla="*/ 225910 w 1731981"/>
              <a:gd name="connsiteY4" fmla="*/ 107577 h 172123"/>
              <a:gd name="connsiteX5" fmla="*/ 258183 w 1731981"/>
              <a:gd name="connsiteY5" fmla="*/ 118335 h 172123"/>
              <a:gd name="connsiteX6" fmla="*/ 311971 w 1731981"/>
              <a:gd name="connsiteY6" fmla="*/ 129092 h 172123"/>
              <a:gd name="connsiteX7" fmla="*/ 408790 w 1731981"/>
              <a:gd name="connsiteY7" fmla="*/ 161365 h 172123"/>
              <a:gd name="connsiteX8" fmla="*/ 441063 w 1731981"/>
              <a:gd name="connsiteY8" fmla="*/ 172123 h 172123"/>
              <a:gd name="connsiteX9" fmla="*/ 591670 w 1731981"/>
              <a:gd name="connsiteY9" fmla="*/ 150607 h 172123"/>
              <a:gd name="connsiteX10" fmla="*/ 688489 w 1731981"/>
              <a:gd name="connsiteY10" fmla="*/ 118335 h 172123"/>
              <a:gd name="connsiteX11" fmla="*/ 720762 w 1731981"/>
              <a:gd name="connsiteY11" fmla="*/ 107577 h 172123"/>
              <a:gd name="connsiteX12" fmla="*/ 946673 w 1731981"/>
              <a:gd name="connsiteY12" fmla="*/ 86062 h 172123"/>
              <a:gd name="connsiteX13" fmla="*/ 989703 w 1731981"/>
              <a:gd name="connsiteY13" fmla="*/ 75304 h 172123"/>
              <a:gd name="connsiteX14" fmla="*/ 1172583 w 1731981"/>
              <a:gd name="connsiteY14" fmla="*/ 43031 h 172123"/>
              <a:gd name="connsiteX15" fmla="*/ 1376978 w 1731981"/>
              <a:gd name="connsiteY15" fmla="*/ 53789 h 172123"/>
              <a:gd name="connsiteX16" fmla="*/ 1635162 w 1731981"/>
              <a:gd name="connsiteY16" fmla="*/ 64546 h 172123"/>
              <a:gd name="connsiteX17" fmla="*/ 1678193 w 1731981"/>
              <a:gd name="connsiteY17" fmla="*/ 75304 h 172123"/>
              <a:gd name="connsiteX18" fmla="*/ 1731981 w 1731981"/>
              <a:gd name="connsiteY18" fmla="*/ 86062 h 1721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731981" h="172123">
                <a:moveTo>
                  <a:pt x="0" y="0"/>
                </a:moveTo>
                <a:cubicBezTo>
                  <a:pt x="25101" y="14344"/>
                  <a:pt x="49054" y="30916"/>
                  <a:pt x="75303" y="43031"/>
                </a:cubicBezTo>
                <a:cubicBezTo>
                  <a:pt x="95895" y="52535"/>
                  <a:pt x="139849" y="64546"/>
                  <a:pt x="139849" y="64546"/>
                </a:cubicBezTo>
                <a:cubicBezTo>
                  <a:pt x="147021" y="71718"/>
                  <a:pt x="152292" y="81526"/>
                  <a:pt x="161364" y="86062"/>
                </a:cubicBezTo>
                <a:cubicBezTo>
                  <a:pt x="181649" y="96205"/>
                  <a:pt x="204395" y="100405"/>
                  <a:pt x="225910" y="107577"/>
                </a:cubicBezTo>
                <a:cubicBezTo>
                  <a:pt x="236668" y="111163"/>
                  <a:pt x="247064" y="116111"/>
                  <a:pt x="258183" y="118335"/>
                </a:cubicBezTo>
                <a:cubicBezTo>
                  <a:pt x="276112" y="121921"/>
                  <a:pt x="294331" y="124281"/>
                  <a:pt x="311971" y="129092"/>
                </a:cubicBezTo>
                <a:cubicBezTo>
                  <a:pt x="311990" y="129097"/>
                  <a:pt x="392644" y="155983"/>
                  <a:pt x="408790" y="161365"/>
                </a:cubicBezTo>
                <a:lnTo>
                  <a:pt x="441063" y="172123"/>
                </a:lnTo>
                <a:cubicBezTo>
                  <a:pt x="515834" y="164646"/>
                  <a:pt x="533172" y="168156"/>
                  <a:pt x="591670" y="150607"/>
                </a:cubicBezTo>
                <a:cubicBezTo>
                  <a:pt x="624254" y="140832"/>
                  <a:pt x="656216" y="129092"/>
                  <a:pt x="688489" y="118335"/>
                </a:cubicBezTo>
                <a:cubicBezTo>
                  <a:pt x="699247" y="114749"/>
                  <a:pt x="709451" y="108385"/>
                  <a:pt x="720762" y="107577"/>
                </a:cubicBezTo>
                <a:cubicBezTo>
                  <a:pt x="808980" y="101275"/>
                  <a:pt x="865718" y="100781"/>
                  <a:pt x="946673" y="86062"/>
                </a:cubicBezTo>
                <a:cubicBezTo>
                  <a:pt x="961219" y="83417"/>
                  <a:pt x="975246" y="78402"/>
                  <a:pt x="989703" y="75304"/>
                </a:cubicBezTo>
                <a:cubicBezTo>
                  <a:pt x="1095646" y="52602"/>
                  <a:pt x="1079451" y="56336"/>
                  <a:pt x="1172583" y="43031"/>
                </a:cubicBezTo>
                <a:lnTo>
                  <a:pt x="1376978" y="53789"/>
                </a:lnTo>
                <a:cubicBezTo>
                  <a:pt x="1463021" y="57791"/>
                  <a:pt x="1549245" y="58409"/>
                  <a:pt x="1635162" y="64546"/>
                </a:cubicBezTo>
                <a:cubicBezTo>
                  <a:pt x="1649910" y="65599"/>
                  <a:pt x="1663760" y="72097"/>
                  <a:pt x="1678193" y="75304"/>
                </a:cubicBezTo>
                <a:cubicBezTo>
                  <a:pt x="1696042" y="79271"/>
                  <a:pt x="1731981" y="86062"/>
                  <a:pt x="1731981" y="86062"/>
                </a:cubicBezTo>
              </a:path>
            </a:pathLst>
          </a:custGeom>
          <a:noFill/>
          <a:ln w="57150">
            <a:solidFill>
              <a:srgbClr val="00B0F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フリーフォーム 11">
            <a:extLst>
              <a:ext uri="{FF2B5EF4-FFF2-40B4-BE49-F238E27FC236}">
                <a16:creationId xmlns:a16="http://schemas.microsoft.com/office/drawing/2014/main" id="{50B27C0C-2F5E-EBA6-048D-3461D08EBD3C}"/>
              </a:ext>
            </a:extLst>
          </p:cNvPr>
          <p:cNvSpPr/>
          <p:nvPr/>
        </p:nvSpPr>
        <p:spPr>
          <a:xfrm>
            <a:off x="6078071" y="2662747"/>
            <a:ext cx="1785219" cy="341764"/>
          </a:xfrm>
          <a:custGeom>
            <a:avLst/>
            <a:gdLst>
              <a:gd name="connsiteX0" fmla="*/ 0 w 1678193"/>
              <a:gd name="connsiteY0" fmla="*/ 333487 h 333487"/>
              <a:gd name="connsiteX1" fmla="*/ 86061 w 1678193"/>
              <a:gd name="connsiteY1" fmla="*/ 311972 h 333487"/>
              <a:gd name="connsiteX2" fmla="*/ 118334 w 1678193"/>
              <a:gd name="connsiteY2" fmla="*/ 301215 h 333487"/>
              <a:gd name="connsiteX3" fmla="*/ 139850 w 1678193"/>
              <a:gd name="connsiteY3" fmla="*/ 279699 h 333487"/>
              <a:gd name="connsiteX4" fmla="*/ 204396 w 1678193"/>
              <a:gd name="connsiteY4" fmla="*/ 236669 h 333487"/>
              <a:gd name="connsiteX5" fmla="*/ 236668 w 1678193"/>
              <a:gd name="connsiteY5" fmla="*/ 215153 h 333487"/>
              <a:gd name="connsiteX6" fmla="*/ 268941 w 1678193"/>
              <a:gd name="connsiteY6" fmla="*/ 204396 h 333487"/>
              <a:gd name="connsiteX7" fmla="*/ 322730 w 1678193"/>
              <a:gd name="connsiteY7" fmla="*/ 172123 h 333487"/>
              <a:gd name="connsiteX8" fmla="*/ 376518 w 1678193"/>
              <a:gd name="connsiteY8" fmla="*/ 139850 h 333487"/>
              <a:gd name="connsiteX9" fmla="*/ 785308 w 1678193"/>
              <a:gd name="connsiteY9" fmla="*/ 150607 h 333487"/>
              <a:gd name="connsiteX10" fmla="*/ 860612 w 1678193"/>
              <a:gd name="connsiteY10" fmla="*/ 161365 h 333487"/>
              <a:gd name="connsiteX11" fmla="*/ 1258645 w 1678193"/>
              <a:gd name="connsiteY11" fmla="*/ 150607 h 333487"/>
              <a:gd name="connsiteX12" fmla="*/ 1344706 w 1678193"/>
              <a:gd name="connsiteY12" fmla="*/ 139850 h 333487"/>
              <a:gd name="connsiteX13" fmla="*/ 1376979 w 1678193"/>
              <a:gd name="connsiteY13" fmla="*/ 129092 h 333487"/>
              <a:gd name="connsiteX14" fmla="*/ 1420010 w 1678193"/>
              <a:gd name="connsiteY14" fmla="*/ 118335 h 333487"/>
              <a:gd name="connsiteX15" fmla="*/ 1484556 w 1678193"/>
              <a:gd name="connsiteY15" fmla="*/ 96819 h 333487"/>
              <a:gd name="connsiteX16" fmla="*/ 1516828 w 1678193"/>
              <a:gd name="connsiteY16" fmla="*/ 86062 h 333487"/>
              <a:gd name="connsiteX17" fmla="*/ 1549101 w 1678193"/>
              <a:gd name="connsiteY17" fmla="*/ 75304 h 333487"/>
              <a:gd name="connsiteX18" fmla="*/ 1602890 w 1678193"/>
              <a:gd name="connsiteY18" fmla="*/ 43031 h 333487"/>
              <a:gd name="connsiteX19" fmla="*/ 1635163 w 1678193"/>
              <a:gd name="connsiteY19" fmla="*/ 21516 h 333487"/>
              <a:gd name="connsiteX20" fmla="*/ 1678193 w 1678193"/>
              <a:gd name="connsiteY20" fmla="*/ 0 h 3334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1678193" h="333487">
                <a:moveTo>
                  <a:pt x="0" y="333487"/>
                </a:moveTo>
                <a:cubicBezTo>
                  <a:pt x="28687" y="326315"/>
                  <a:pt x="57533" y="319752"/>
                  <a:pt x="86061" y="311972"/>
                </a:cubicBezTo>
                <a:cubicBezTo>
                  <a:pt x="97001" y="308988"/>
                  <a:pt x="108610" y="307049"/>
                  <a:pt x="118334" y="301215"/>
                </a:cubicBezTo>
                <a:cubicBezTo>
                  <a:pt x="127031" y="295997"/>
                  <a:pt x="131736" y="285785"/>
                  <a:pt x="139850" y="279699"/>
                </a:cubicBezTo>
                <a:cubicBezTo>
                  <a:pt x="160537" y="264184"/>
                  <a:pt x="182881" y="251013"/>
                  <a:pt x="204396" y="236669"/>
                </a:cubicBezTo>
                <a:cubicBezTo>
                  <a:pt x="215154" y="229497"/>
                  <a:pt x="224402" y="219241"/>
                  <a:pt x="236668" y="215153"/>
                </a:cubicBezTo>
                <a:lnTo>
                  <a:pt x="268941" y="204396"/>
                </a:lnTo>
                <a:cubicBezTo>
                  <a:pt x="323460" y="149877"/>
                  <a:pt x="252902" y="214020"/>
                  <a:pt x="322730" y="172123"/>
                </a:cubicBezTo>
                <a:cubicBezTo>
                  <a:pt x="396563" y="127823"/>
                  <a:pt x="285094" y="170323"/>
                  <a:pt x="376518" y="139850"/>
                </a:cubicBezTo>
                <a:lnTo>
                  <a:pt x="785308" y="150607"/>
                </a:lnTo>
                <a:cubicBezTo>
                  <a:pt x="810639" y="151733"/>
                  <a:pt x="835256" y="161365"/>
                  <a:pt x="860612" y="161365"/>
                </a:cubicBezTo>
                <a:cubicBezTo>
                  <a:pt x="993338" y="161365"/>
                  <a:pt x="1125967" y="154193"/>
                  <a:pt x="1258645" y="150607"/>
                </a:cubicBezTo>
                <a:cubicBezTo>
                  <a:pt x="1287332" y="147021"/>
                  <a:pt x="1316262" y="145022"/>
                  <a:pt x="1344706" y="139850"/>
                </a:cubicBezTo>
                <a:cubicBezTo>
                  <a:pt x="1355863" y="137822"/>
                  <a:pt x="1366076" y="132207"/>
                  <a:pt x="1376979" y="129092"/>
                </a:cubicBezTo>
                <a:cubicBezTo>
                  <a:pt x="1391195" y="125030"/>
                  <a:pt x="1405848" y="122583"/>
                  <a:pt x="1420010" y="118335"/>
                </a:cubicBezTo>
                <a:cubicBezTo>
                  <a:pt x="1441733" y="111818"/>
                  <a:pt x="1463041" y="103991"/>
                  <a:pt x="1484556" y="96819"/>
                </a:cubicBezTo>
                <a:lnTo>
                  <a:pt x="1516828" y="86062"/>
                </a:lnTo>
                <a:lnTo>
                  <a:pt x="1549101" y="75304"/>
                </a:lnTo>
                <a:cubicBezTo>
                  <a:pt x="1591127" y="33280"/>
                  <a:pt x="1547030" y="70961"/>
                  <a:pt x="1602890" y="43031"/>
                </a:cubicBezTo>
                <a:cubicBezTo>
                  <a:pt x="1614454" y="37249"/>
                  <a:pt x="1623599" y="27298"/>
                  <a:pt x="1635163" y="21516"/>
                </a:cubicBezTo>
                <a:cubicBezTo>
                  <a:pt x="1684605" y="-3205"/>
                  <a:pt x="1653891" y="24304"/>
                  <a:pt x="1678193" y="0"/>
                </a:cubicBezTo>
              </a:path>
            </a:pathLst>
          </a:custGeom>
          <a:noFill/>
          <a:ln w="57150">
            <a:solidFill>
              <a:srgbClr val="00B0F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フリーフォーム 12">
            <a:extLst>
              <a:ext uri="{FF2B5EF4-FFF2-40B4-BE49-F238E27FC236}">
                <a16:creationId xmlns:a16="http://schemas.microsoft.com/office/drawing/2014/main" id="{DB3298DF-90D6-5F60-E221-06B2F76EF1C2}"/>
              </a:ext>
            </a:extLst>
          </p:cNvPr>
          <p:cNvSpPr/>
          <p:nvPr/>
        </p:nvSpPr>
        <p:spPr>
          <a:xfrm>
            <a:off x="2097741" y="2872292"/>
            <a:ext cx="839097" cy="161364"/>
          </a:xfrm>
          <a:custGeom>
            <a:avLst/>
            <a:gdLst>
              <a:gd name="connsiteX0" fmla="*/ 0 w 839097"/>
              <a:gd name="connsiteY0" fmla="*/ 161364 h 161364"/>
              <a:gd name="connsiteX1" fmla="*/ 75304 w 839097"/>
              <a:gd name="connsiteY1" fmla="*/ 129092 h 161364"/>
              <a:gd name="connsiteX2" fmla="*/ 96819 w 839097"/>
              <a:gd name="connsiteY2" fmla="*/ 107576 h 161364"/>
              <a:gd name="connsiteX3" fmla="*/ 161365 w 839097"/>
              <a:gd name="connsiteY3" fmla="*/ 64546 h 161364"/>
              <a:gd name="connsiteX4" fmla="*/ 225911 w 839097"/>
              <a:gd name="connsiteY4" fmla="*/ 21515 h 161364"/>
              <a:gd name="connsiteX5" fmla="*/ 268941 w 839097"/>
              <a:gd name="connsiteY5" fmla="*/ 0 h 161364"/>
              <a:gd name="connsiteX6" fmla="*/ 365760 w 839097"/>
              <a:gd name="connsiteY6" fmla="*/ 10757 h 161364"/>
              <a:gd name="connsiteX7" fmla="*/ 430306 w 839097"/>
              <a:gd name="connsiteY7" fmla="*/ 32273 h 161364"/>
              <a:gd name="connsiteX8" fmla="*/ 462579 w 839097"/>
              <a:gd name="connsiteY8" fmla="*/ 43030 h 161364"/>
              <a:gd name="connsiteX9" fmla="*/ 494852 w 839097"/>
              <a:gd name="connsiteY9" fmla="*/ 64546 h 161364"/>
              <a:gd name="connsiteX10" fmla="*/ 527125 w 839097"/>
              <a:gd name="connsiteY10" fmla="*/ 75303 h 161364"/>
              <a:gd name="connsiteX11" fmla="*/ 666974 w 839097"/>
              <a:gd name="connsiteY11" fmla="*/ 96819 h 161364"/>
              <a:gd name="connsiteX12" fmla="*/ 753035 w 839097"/>
              <a:gd name="connsiteY12" fmla="*/ 107576 h 161364"/>
              <a:gd name="connsiteX13" fmla="*/ 839097 w 839097"/>
              <a:gd name="connsiteY13" fmla="*/ 118334 h 161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839097" h="161364">
                <a:moveTo>
                  <a:pt x="0" y="161364"/>
                </a:moveTo>
                <a:cubicBezTo>
                  <a:pt x="25101" y="150607"/>
                  <a:pt x="51431" y="142354"/>
                  <a:pt x="75304" y="129092"/>
                </a:cubicBezTo>
                <a:cubicBezTo>
                  <a:pt x="84170" y="124166"/>
                  <a:pt x="88705" y="113662"/>
                  <a:pt x="96819" y="107576"/>
                </a:cubicBezTo>
                <a:cubicBezTo>
                  <a:pt x="117505" y="92061"/>
                  <a:pt x="139850" y="78889"/>
                  <a:pt x="161365" y="64546"/>
                </a:cubicBezTo>
                <a:cubicBezTo>
                  <a:pt x="161372" y="64541"/>
                  <a:pt x="225903" y="21519"/>
                  <a:pt x="225911" y="21515"/>
                </a:cubicBezTo>
                <a:lnTo>
                  <a:pt x="268941" y="0"/>
                </a:lnTo>
                <a:cubicBezTo>
                  <a:pt x="301214" y="3586"/>
                  <a:pt x="333919" y="4389"/>
                  <a:pt x="365760" y="10757"/>
                </a:cubicBezTo>
                <a:cubicBezTo>
                  <a:pt x="387999" y="15205"/>
                  <a:pt x="408791" y="25101"/>
                  <a:pt x="430306" y="32273"/>
                </a:cubicBezTo>
                <a:lnTo>
                  <a:pt x="462579" y="43030"/>
                </a:lnTo>
                <a:cubicBezTo>
                  <a:pt x="473337" y="50202"/>
                  <a:pt x="483288" y="58764"/>
                  <a:pt x="494852" y="64546"/>
                </a:cubicBezTo>
                <a:cubicBezTo>
                  <a:pt x="504994" y="69617"/>
                  <a:pt x="516222" y="72188"/>
                  <a:pt x="527125" y="75303"/>
                </a:cubicBezTo>
                <a:cubicBezTo>
                  <a:pt x="587798" y="92638"/>
                  <a:pt x="585899" y="87281"/>
                  <a:pt x="666974" y="96819"/>
                </a:cubicBezTo>
                <a:cubicBezTo>
                  <a:pt x="695686" y="100197"/>
                  <a:pt x="724461" y="103180"/>
                  <a:pt x="753035" y="107576"/>
                </a:cubicBezTo>
                <a:cubicBezTo>
                  <a:pt x="836677" y="120444"/>
                  <a:pt x="777182" y="118334"/>
                  <a:pt x="839097" y="118334"/>
                </a:cubicBezTo>
              </a:path>
            </a:pathLst>
          </a:custGeom>
          <a:noFill/>
          <a:ln w="57150">
            <a:solidFill>
              <a:srgbClr val="00B0F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下矢印 13">
            <a:extLst>
              <a:ext uri="{FF2B5EF4-FFF2-40B4-BE49-F238E27FC236}">
                <a16:creationId xmlns:a16="http://schemas.microsoft.com/office/drawing/2014/main" id="{10CD2A3F-58C6-CC58-C1B9-C6068D9765F4}"/>
              </a:ext>
            </a:extLst>
          </p:cNvPr>
          <p:cNvSpPr/>
          <p:nvPr/>
        </p:nvSpPr>
        <p:spPr>
          <a:xfrm>
            <a:off x="3654823" y="5272212"/>
            <a:ext cx="914400" cy="367177"/>
          </a:xfrm>
          <a:prstGeom prst="downArrow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下矢印 14">
            <a:extLst>
              <a:ext uri="{FF2B5EF4-FFF2-40B4-BE49-F238E27FC236}">
                <a16:creationId xmlns:a16="http://schemas.microsoft.com/office/drawing/2014/main" id="{0F23741D-B6B1-D22B-432E-D464D308E3A5}"/>
              </a:ext>
            </a:extLst>
          </p:cNvPr>
          <p:cNvSpPr/>
          <p:nvPr/>
        </p:nvSpPr>
        <p:spPr>
          <a:xfrm>
            <a:off x="9939051" y="5272212"/>
            <a:ext cx="914400" cy="367177"/>
          </a:xfrm>
          <a:prstGeom prst="downArrow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705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</TotalTime>
  <Words>56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游明朝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増田 充弘</dc:creator>
  <cp:lastModifiedBy>美香 三木</cp:lastModifiedBy>
  <cp:revision>3</cp:revision>
  <dcterms:created xsi:type="dcterms:W3CDTF">2023-11-13T23:05:53Z</dcterms:created>
  <dcterms:modified xsi:type="dcterms:W3CDTF">2024-08-14T06:11:01Z</dcterms:modified>
</cp:coreProperties>
</file>